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</p:sldIdLst>
  <p:sldSz cx="5039995" cy="10439400"/>
  <p:notesSz cx="6858000" cy="9144000"/>
  <p:custDataLst>
    <p:tags r:id="rId9"/>
  </p:custDataLst>
  <p:defaultTextStyle>
    <a:defPPr>
      <a:defRPr lang="en-US"/>
    </a:defPPr>
    <a:lvl1pPr marL="0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1pPr>
    <a:lvl2pPr marL="374015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2pPr>
    <a:lvl3pPr marL="748665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3pPr>
    <a:lvl4pPr marL="1122680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4pPr>
    <a:lvl5pPr marL="1497330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5pPr>
    <a:lvl6pPr marL="1871345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6pPr>
    <a:lvl7pPr marL="2245360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7pPr>
    <a:lvl8pPr marL="2620010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8pPr>
    <a:lvl9pPr marL="2994025" algn="l" defTabSz="748665" rtl="0" eaLnBrk="1" latinLnBrk="0" hangingPunct="1">
      <a:defRPr sz="149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88" userDrawn="1">
          <p15:clr>
            <a:srgbClr val="A4A3A4"/>
          </p15:clr>
        </p15:guide>
        <p15:guide id="2" pos="155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hristopher Vautrinot - Springer Healthcare UK" initials="CV-SHU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918D"/>
    <a:srgbClr val="BF2821"/>
    <a:srgbClr val="FF6600"/>
    <a:srgbClr val="C32A24"/>
    <a:srgbClr val="0B509D"/>
    <a:srgbClr val="009185"/>
    <a:srgbClr val="9E9C9C"/>
    <a:srgbClr val="004D88"/>
    <a:srgbClr val="B40636"/>
    <a:srgbClr val="52BF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12" autoAdjust="0"/>
    <p:restoredTop sz="94660"/>
  </p:normalViewPr>
  <p:slideViewPr>
    <p:cSldViewPr showGuides="1">
      <p:cViewPr varScale="1">
        <p:scale>
          <a:sx n="97" d="100"/>
          <a:sy n="97" d="100"/>
        </p:scale>
        <p:origin x="4227" y="62"/>
      </p:cViewPr>
      <p:guideLst>
        <p:guide orient="horz" pos="3288"/>
        <p:guide pos="15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5236B9-0A1E-4AC4-BE94-150A71551B14}" type="datetimeFigureOut">
              <a:rPr lang="en-NZ" smtClean="0"/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84463" y="1143000"/>
            <a:ext cx="1489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9E62CE-D415-437D-B19F-AF388FC48AE0}" type="slidenum">
              <a:rPr lang="en-NZ" smtClean="0"/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9E62CE-D415-437D-B19F-AF388FC48AE0}" type="slidenum">
              <a:rPr lang="en-NZ" smtClean="0"/>
            </a:fld>
            <a:endParaRPr lang="en-NZ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3242983"/>
            <a:ext cx="4284266" cy="22377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56048" y="5915661"/>
            <a:ext cx="3528219" cy="266784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308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623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931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239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554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86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17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6479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4397" y="1099523"/>
            <a:ext cx="1357209" cy="2340407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1895" y="1099523"/>
            <a:ext cx="3988498" cy="2340407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8151" y="6708284"/>
            <a:ext cx="4284266" cy="2073381"/>
          </a:xfrm>
        </p:spPr>
        <p:txBody>
          <a:bodyPr anchor="t"/>
          <a:lstStyle>
            <a:lvl1pPr algn="l">
              <a:defRPr sz="288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8151" y="4424664"/>
            <a:ext cx="4284266" cy="2283618"/>
          </a:xfrm>
        </p:spPr>
        <p:txBody>
          <a:bodyPr anchor="b"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330835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2pPr>
            <a:lvl3pPr marL="662305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3pPr>
            <a:lvl4pPr marL="99314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2397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5544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98628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1711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64795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1895" y="6401384"/>
            <a:ext cx="2672416" cy="18102209"/>
          </a:xfrm>
        </p:spPr>
        <p:txBody>
          <a:bodyPr/>
          <a:lstStyle>
            <a:lvl1pPr>
              <a:defRPr sz="2040"/>
            </a:lvl1pPr>
            <a:lvl2pPr>
              <a:defRPr sz="1720"/>
            </a:lvl2pPr>
            <a:lvl3pPr>
              <a:defRPr sz="1440"/>
            </a:lvl3pPr>
            <a:lvl4pPr>
              <a:defRPr sz="1320"/>
            </a:lvl4pPr>
            <a:lvl5pPr>
              <a:defRPr sz="1320"/>
            </a:lvl5pPr>
            <a:lvl6pPr>
              <a:defRPr sz="1320"/>
            </a:lvl6pPr>
            <a:lvl7pPr>
              <a:defRPr sz="1320"/>
            </a:lvl7pPr>
            <a:lvl8pPr>
              <a:defRPr sz="1320"/>
            </a:lvl8pPr>
            <a:lvl9pPr>
              <a:defRPr sz="132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8316" y="6401384"/>
            <a:ext cx="2673291" cy="18102209"/>
          </a:xfrm>
        </p:spPr>
        <p:txBody>
          <a:bodyPr/>
          <a:lstStyle>
            <a:lvl1pPr>
              <a:defRPr sz="2040"/>
            </a:lvl1pPr>
            <a:lvl2pPr>
              <a:defRPr sz="1720"/>
            </a:lvl2pPr>
            <a:lvl3pPr>
              <a:defRPr sz="1440"/>
            </a:lvl3pPr>
            <a:lvl4pPr>
              <a:defRPr sz="1320"/>
            </a:lvl4pPr>
            <a:lvl5pPr>
              <a:defRPr sz="1320"/>
            </a:lvl5pPr>
            <a:lvl6pPr>
              <a:defRPr sz="1320"/>
            </a:lvl6pPr>
            <a:lvl7pPr>
              <a:defRPr sz="1320"/>
            </a:lvl7pPr>
            <a:lvl8pPr>
              <a:defRPr sz="1320"/>
            </a:lvl8pPr>
            <a:lvl9pPr>
              <a:defRPr sz="132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2016" y="418060"/>
            <a:ext cx="4536282" cy="17399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15" y="2336783"/>
            <a:ext cx="2227014" cy="973860"/>
          </a:xfrm>
        </p:spPr>
        <p:txBody>
          <a:bodyPr anchor="b"/>
          <a:lstStyle>
            <a:lvl1pPr marL="0" indent="0">
              <a:buNone/>
              <a:defRPr sz="1720" b="1"/>
            </a:lvl1pPr>
            <a:lvl2pPr marL="330835" indent="0">
              <a:buNone/>
              <a:defRPr sz="1440" b="1"/>
            </a:lvl2pPr>
            <a:lvl3pPr marL="662305" indent="0">
              <a:buNone/>
              <a:defRPr sz="1320" b="1"/>
            </a:lvl3pPr>
            <a:lvl4pPr marL="993140" indent="0">
              <a:buNone/>
              <a:defRPr sz="1160" b="1"/>
            </a:lvl4pPr>
            <a:lvl5pPr marL="1323975" indent="0">
              <a:buNone/>
              <a:defRPr sz="1160" b="1"/>
            </a:lvl5pPr>
            <a:lvl6pPr marL="1655445" indent="0">
              <a:buNone/>
              <a:defRPr sz="1160" b="1"/>
            </a:lvl6pPr>
            <a:lvl7pPr marL="1986280" indent="0">
              <a:buNone/>
              <a:defRPr sz="1160" b="1"/>
            </a:lvl7pPr>
            <a:lvl8pPr marL="2317115" indent="0">
              <a:buNone/>
              <a:defRPr sz="1160" b="1"/>
            </a:lvl8pPr>
            <a:lvl9pPr marL="2647950" indent="0">
              <a:buNone/>
              <a:defRPr sz="116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2015" y="3310643"/>
            <a:ext cx="2227014" cy="6014738"/>
          </a:xfrm>
        </p:spPr>
        <p:txBody>
          <a:bodyPr/>
          <a:lstStyle>
            <a:lvl1pPr>
              <a:defRPr sz="1720"/>
            </a:lvl1pPr>
            <a:lvl2pPr>
              <a:defRPr sz="1440"/>
            </a:lvl2pPr>
            <a:lvl3pPr>
              <a:defRPr sz="1320"/>
            </a:lvl3pPr>
            <a:lvl4pPr>
              <a:defRPr sz="1160"/>
            </a:lvl4pPr>
            <a:lvl5pPr>
              <a:defRPr sz="1160"/>
            </a:lvl5pPr>
            <a:lvl6pPr>
              <a:defRPr sz="1160"/>
            </a:lvl6pPr>
            <a:lvl7pPr>
              <a:defRPr sz="1160"/>
            </a:lvl7pPr>
            <a:lvl8pPr>
              <a:defRPr sz="1160"/>
            </a:lvl8pPr>
            <a:lvl9pPr>
              <a:defRPr sz="116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60411" y="2336783"/>
            <a:ext cx="2227888" cy="973860"/>
          </a:xfrm>
        </p:spPr>
        <p:txBody>
          <a:bodyPr anchor="b"/>
          <a:lstStyle>
            <a:lvl1pPr marL="0" indent="0">
              <a:buNone/>
              <a:defRPr sz="1720" b="1"/>
            </a:lvl1pPr>
            <a:lvl2pPr marL="330835" indent="0">
              <a:buNone/>
              <a:defRPr sz="1440" b="1"/>
            </a:lvl2pPr>
            <a:lvl3pPr marL="662305" indent="0">
              <a:buNone/>
              <a:defRPr sz="1320" b="1"/>
            </a:lvl3pPr>
            <a:lvl4pPr marL="993140" indent="0">
              <a:buNone/>
              <a:defRPr sz="1160" b="1"/>
            </a:lvl4pPr>
            <a:lvl5pPr marL="1323975" indent="0">
              <a:buNone/>
              <a:defRPr sz="1160" b="1"/>
            </a:lvl5pPr>
            <a:lvl6pPr marL="1655445" indent="0">
              <a:buNone/>
              <a:defRPr sz="1160" b="1"/>
            </a:lvl6pPr>
            <a:lvl7pPr marL="1986280" indent="0">
              <a:buNone/>
              <a:defRPr sz="1160" b="1"/>
            </a:lvl7pPr>
            <a:lvl8pPr marL="2317115" indent="0">
              <a:buNone/>
              <a:defRPr sz="1160" b="1"/>
            </a:lvl8pPr>
            <a:lvl9pPr marL="2647950" indent="0">
              <a:buNone/>
              <a:defRPr sz="116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60411" y="3310643"/>
            <a:ext cx="2227888" cy="6014738"/>
          </a:xfrm>
        </p:spPr>
        <p:txBody>
          <a:bodyPr/>
          <a:lstStyle>
            <a:lvl1pPr>
              <a:defRPr sz="1720"/>
            </a:lvl1pPr>
            <a:lvl2pPr>
              <a:defRPr sz="1440"/>
            </a:lvl2pPr>
            <a:lvl3pPr>
              <a:defRPr sz="1320"/>
            </a:lvl3pPr>
            <a:lvl4pPr>
              <a:defRPr sz="1160"/>
            </a:lvl4pPr>
            <a:lvl5pPr>
              <a:defRPr sz="1160"/>
            </a:lvl5pPr>
            <a:lvl6pPr>
              <a:defRPr sz="1160"/>
            </a:lvl6pPr>
            <a:lvl7pPr>
              <a:defRPr sz="1160"/>
            </a:lvl7pPr>
            <a:lvl8pPr>
              <a:defRPr sz="1160"/>
            </a:lvl8pPr>
            <a:lvl9pPr>
              <a:defRPr sz="116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2017" y="415643"/>
            <a:ext cx="1658228" cy="1768898"/>
          </a:xfrm>
        </p:spPr>
        <p:txBody>
          <a:bodyPr anchor="b"/>
          <a:lstStyle>
            <a:lvl1pPr algn="l">
              <a:defRPr sz="144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70624" y="415645"/>
            <a:ext cx="2817675" cy="8909739"/>
          </a:xfrm>
        </p:spPr>
        <p:txBody>
          <a:bodyPr/>
          <a:lstStyle>
            <a:lvl1pPr>
              <a:defRPr sz="2320"/>
            </a:lvl1pPr>
            <a:lvl2pPr>
              <a:defRPr sz="2040"/>
            </a:lvl2pPr>
            <a:lvl3pPr>
              <a:defRPr sz="1720"/>
            </a:lvl3pPr>
            <a:lvl4pPr>
              <a:defRPr sz="1440"/>
            </a:lvl4pPr>
            <a:lvl5pPr>
              <a:defRPr sz="1440"/>
            </a:lvl5pPr>
            <a:lvl6pPr>
              <a:defRPr sz="1440"/>
            </a:lvl6pPr>
            <a:lvl7pPr>
              <a:defRPr sz="1440"/>
            </a:lvl7pPr>
            <a:lvl8pPr>
              <a:defRPr sz="1440"/>
            </a:lvl8pPr>
            <a:lvl9pPr>
              <a:defRPr sz="144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2017" y="2184543"/>
            <a:ext cx="1658228" cy="7140841"/>
          </a:xfrm>
        </p:spPr>
        <p:txBody>
          <a:bodyPr/>
          <a:lstStyle>
            <a:lvl1pPr marL="0" indent="0">
              <a:buNone/>
              <a:defRPr sz="1000"/>
            </a:lvl1pPr>
            <a:lvl2pPr marL="330835" indent="0">
              <a:buNone/>
              <a:defRPr sz="880"/>
            </a:lvl2pPr>
            <a:lvl3pPr marL="662305" indent="0">
              <a:buNone/>
              <a:defRPr sz="720"/>
            </a:lvl3pPr>
            <a:lvl4pPr marL="993140" indent="0">
              <a:buNone/>
              <a:defRPr sz="640"/>
            </a:lvl4pPr>
            <a:lvl5pPr marL="1323975" indent="0">
              <a:buNone/>
              <a:defRPr sz="640"/>
            </a:lvl5pPr>
            <a:lvl6pPr marL="1655445" indent="0">
              <a:buNone/>
              <a:defRPr sz="640"/>
            </a:lvl6pPr>
            <a:lvl7pPr marL="1986280" indent="0">
              <a:buNone/>
              <a:defRPr sz="640"/>
            </a:lvl7pPr>
            <a:lvl8pPr marL="2317115" indent="0">
              <a:buNone/>
              <a:defRPr sz="640"/>
            </a:lvl8pPr>
            <a:lvl9pPr marL="2647950" indent="0">
              <a:buNone/>
              <a:defRPr sz="64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7937" y="7307581"/>
            <a:ext cx="3024188" cy="862701"/>
          </a:xfrm>
        </p:spPr>
        <p:txBody>
          <a:bodyPr anchor="b"/>
          <a:lstStyle>
            <a:lvl1pPr algn="l">
              <a:defRPr sz="144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987937" y="932780"/>
            <a:ext cx="3024188" cy="6263640"/>
          </a:xfrm>
        </p:spPr>
        <p:txBody>
          <a:bodyPr/>
          <a:lstStyle>
            <a:lvl1pPr marL="0" indent="0">
              <a:buNone/>
              <a:defRPr sz="2320"/>
            </a:lvl1pPr>
            <a:lvl2pPr marL="330835" indent="0">
              <a:buNone/>
              <a:defRPr sz="2040"/>
            </a:lvl2pPr>
            <a:lvl3pPr marL="662305" indent="0">
              <a:buNone/>
              <a:defRPr sz="1720"/>
            </a:lvl3pPr>
            <a:lvl4pPr marL="993140" indent="0">
              <a:buNone/>
              <a:defRPr sz="1440"/>
            </a:lvl4pPr>
            <a:lvl5pPr marL="1323975" indent="0">
              <a:buNone/>
              <a:defRPr sz="1440"/>
            </a:lvl5pPr>
            <a:lvl6pPr marL="1655445" indent="0">
              <a:buNone/>
              <a:defRPr sz="1440"/>
            </a:lvl6pPr>
            <a:lvl7pPr marL="1986280" indent="0">
              <a:buNone/>
              <a:defRPr sz="1440"/>
            </a:lvl7pPr>
            <a:lvl8pPr marL="2317115" indent="0">
              <a:buNone/>
              <a:defRPr sz="1440"/>
            </a:lvl8pPr>
            <a:lvl9pPr marL="2647950" indent="0">
              <a:buNone/>
              <a:defRPr sz="144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87937" y="8170282"/>
            <a:ext cx="3024188" cy="1225179"/>
          </a:xfrm>
        </p:spPr>
        <p:txBody>
          <a:bodyPr/>
          <a:lstStyle>
            <a:lvl1pPr marL="0" indent="0">
              <a:buNone/>
              <a:defRPr sz="1000"/>
            </a:lvl1pPr>
            <a:lvl2pPr marL="330835" indent="0">
              <a:buNone/>
              <a:defRPr sz="880"/>
            </a:lvl2pPr>
            <a:lvl3pPr marL="662305" indent="0">
              <a:buNone/>
              <a:defRPr sz="720"/>
            </a:lvl3pPr>
            <a:lvl4pPr marL="993140" indent="0">
              <a:buNone/>
              <a:defRPr sz="640"/>
            </a:lvl4pPr>
            <a:lvl5pPr marL="1323975" indent="0">
              <a:buNone/>
              <a:defRPr sz="640"/>
            </a:lvl5pPr>
            <a:lvl6pPr marL="1655445" indent="0">
              <a:buNone/>
              <a:defRPr sz="640"/>
            </a:lvl6pPr>
            <a:lvl7pPr marL="1986280" indent="0">
              <a:buNone/>
              <a:defRPr sz="640"/>
            </a:lvl7pPr>
            <a:lvl8pPr marL="2317115" indent="0">
              <a:buNone/>
              <a:defRPr sz="640"/>
            </a:lvl8pPr>
            <a:lvl9pPr marL="2647950" indent="0">
              <a:buNone/>
              <a:defRPr sz="64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2016" y="418060"/>
            <a:ext cx="4536282" cy="1739900"/>
          </a:xfrm>
          <a:prstGeom prst="rect">
            <a:avLst/>
          </a:prstGeom>
        </p:spPr>
        <p:txBody>
          <a:bodyPr vert="horz" lIns="165516" tIns="82758" rIns="165516" bIns="82758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16" y="2435861"/>
            <a:ext cx="4536282" cy="6889522"/>
          </a:xfrm>
          <a:prstGeom prst="rect">
            <a:avLst/>
          </a:prstGeom>
        </p:spPr>
        <p:txBody>
          <a:bodyPr vert="horz" lIns="165516" tIns="82758" rIns="165516" bIns="82758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2018" y="9675779"/>
            <a:ext cx="1176073" cy="555802"/>
          </a:xfrm>
          <a:prstGeom prst="rect">
            <a:avLst/>
          </a:prstGeom>
        </p:spPr>
        <p:txBody>
          <a:bodyPr vert="horz" lIns="165516" tIns="82758" rIns="165516" bIns="82758" rtlCol="0" anchor="ctr"/>
          <a:lstStyle>
            <a:lvl1pPr algn="l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9724AF-DEF8-4593-81F2-0A06EC8306D2}" type="datetimeFigureOut">
              <a:rPr lang="en-GB" smtClean="0"/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22108" y="9675779"/>
            <a:ext cx="1596099" cy="555802"/>
          </a:xfrm>
          <a:prstGeom prst="rect">
            <a:avLst/>
          </a:prstGeom>
        </p:spPr>
        <p:txBody>
          <a:bodyPr vert="horz" lIns="165516" tIns="82758" rIns="165516" bIns="82758" rtlCol="0" anchor="ctr"/>
          <a:lstStyle>
            <a:lvl1pPr algn="ctr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12226" y="9675779"/>
            <a:ext cx="1176073" cy="555802"/>
          </a:xfrm>
          <a:prstGeom prst="rect">
            <a:avLst/>
          </a:prstGeom>
        </p:spPr>
        <p:txBody>
          <a:bodyPr vert="horz" lIns="165516" tIns="82758" rIns="165516" bIns="82758" rtlCol="0" anchor="ctr"/>
          <a:lstStyle>
            <a:lvl1pPr algn="r">
              <a:defRPr sz="8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271C5-375D-4E16-8CDC-5FBA66CBA8E0}" type="slidenum">
              <a:rPr lang="en-GB" smtClean="0"/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62305" rtl="0" eaLnBrk="1" latinLnBrk="0" hangingPunct="1">
        <a:spcBef>
          <a:spcPct val="0"/>
        </a:spcBef>
        <a:buNone/>
        <a:defRPr sz="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8285" indent="-248285" algn="l" defTabSz="662305" rtl="0" eaLnBrk="1" latinLnBrk="0" hangingPunct="1">
        <a:spcBef>
          <a:spcPct val="20000"/>
        </a:spcBef>
        <a:buFont typeface="Arial" panose="020B0604020202020204" pitchFamily="34" charset="0"/>
        <a:buChar char="•"/>
        <a:defRPr sz="2320" kern="1200">
          <a:solidFill>
            <a:schemeClr val="tx1"/>
          </a:solidFill>
          <a:latin typeface="+mn-lt"/>
          <a:ea typeface="+mn-ea"/>
          <a:cs typeface="+mn-cs"/>
        </a:defRPr>
      </a:lvl1pPr>
      <a:lvl2pPr marL="537845" indent="-207010" algn="l" defTabSz="662305" rtl="0" eaLnBrk="1" latinLnBrk="0" hangingPunct="1">
        <a:spcBef>
          <a:spcPct val="20000"/>
        </a:spcBef>
        <a:buFont typeface="Arial" panose="020B0604020202020204" pitchFamily="34" charset="0"/>
        <a:buChar char="–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827405" indent="-165735" algn="l" defTabSz="662305" rtl="0" eaLnBrk="1" latinLnBrk="0" hangingPunct="1">
        <a:spcBef>
          <a:spcPct val="20000"/>
        </a:spcBef>
        <a:buFont typeface="Arial" panose="020B0604020202020204" pitchFamily="34" charset="0"/>
        <a:buChar char="•"/>
        <a:defRPr sz="1720" kern="1200">
          <a:solidFill>
            <a:schemeClr val="tx1"/>
          </a:solidFill>
          <a:latin typeface="+mn-lt"/>
          <a:ea typeface="+mn-ea"/>
          <a:cs typeface="+mn-cs"/>
        </a:defRPr>
      </a:lvl3pPr>
      <a:lvl4pPr marL="1158875" indent="-165735" algn="l" defTabSz="662305" rtl="0" eaLnBrk="1" latinLnBrk="0" hangingPunct="1">
        <a:spcBef>
          <a:spcPct val="20000"/>
        </a:spcBef>
        <a:buFont typeface="Arial" panose="020B0604020202020204" pitchFamily="34" charset="0"/>
        <a:buChar char="–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89710" indent="-165735" algn="l" defTabSz="662305" rtl="0" eaLnBrk="1" latinLnBrk="0" hangingPunct="1">
        <a:spcBef>
          <a:spcPct val="20000"/>
        </a:spcBef>
        <a:buFont typeface="Arial" panose="020B0604020202020204" pitchFamily="34" charset="0"/>
        <a:buChar char="»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0545" indent="-165735" algn="l" defTabSz="662305" rtl="0" eaLnBrk="1" latinLnBrk="0" hangingPunct="1">
        <a:spcBef>
          <a:spcPct val="200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52015" indent="-165735" algn="l" defTabSz="662305" rtl="0" eaLnBrk="1" latinLnBrk="0" hangingPunct="1">
        <a:spcBef>
          <a:spcPct val="200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482850" indent="-165735" algn="l" defTabSz="662305" rtl="0" eaLnBrk="1" latinLnBrk="0" hangingPunct="1">
        <a:spcBef>
          <a:spcPct val="200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813685" indent="-165735" algn="l" defTabSz="662305" rtl="0" eaLnBrk="1" latinLnBrk="0" hangingPunct="1">
        <a:spcBef>
          <a:spcPct val="200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1pPr>
      <a:lvl2pPr marL="330835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2pPr>
      <a:lvl3pPr marL="662305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3pPr>
      <a:lvl4pPr marL="993140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4pPr>
      <a:lvl5pPr marL="1323975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5pPr>
      <a:lvl6pPr marL="1655445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6pPr>
      <a:lvl7pPr marL="1986280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7pPr>
      <a:lvl8pPr marL="2317115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8pPr>
      <a:lvl9pPr marL="2647950" algn="l" defTabSz="662305" rtl="0" eaLnBrk="1" latinLnBrk="0" hangingPunct="1">
        <a:defRPr sz="13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jpeg"/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51" descr="A black and white shoe print&#10;&#10;Description automatically generated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43" t="15713" r="49446" b="30348"/>
          <a:stretch>
            <a:fillRect/>
          </a:stretch>
        </p:blipFill>
        <p:spPr>
          <a:xfrm rot="15909530" flipV="1">
            <a:off x="448337" y="4341232"/>
            <a:ext cx="278570" cy="556271"/>
          </a:xfrm>
          <a:prstGeom prst="rect">
            <a:avLst/>
          </a:prstGeom>
        </p:spPr>
      </p:pic>
      <p:pic>
        <p:nvPicPr>
          <p:cNvPr id="56" name="Picture 55" descr="A black and white shoe print&#10;&#10;Description automatically generated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43" t="15713" r="49446" b="30348"/>
          <a:stretch>
            <a:fillRect/>
          </a:stretch>
        </p:blipFill>
        <p:spPr>
          <a:xfrm rot="5690470">
            <a:off x="3656270" y="3877176"/>
            <a:ext cx="278570" cy="556271"/>
          </a:xfrm>
          <a:prstGeom prst="rect">
            <a:avLst/>
          </a:prstGeom>
        </p:spPr>
      </p:pic>
      <p:pic>
        <p:nvPicPr>
          <p:cNvPr id="55" name="Picture 54" descr="A black and white shoe print&#10;&#10;Description automatically generated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43" t="15713" r="49446" b="30348"/>
          <a:stretch>
            <a:fillRect/>
          </a:stretch>
        </p:blipFill>
        <p:spPr>
          <a:xfrm rot="5690470">
            <a:off x="2209132" y="3512653"/>
            <a:ext cx="278570" cy="556271"/>
          </a:xfrm>
          <a:prstGeom prst="rect">
            <a:avLst/>
          </a:prstGeom>
        </p:spPr>
      </p:pic>
      <p:pic>
        <p:nvPicPr>
          <p:cNvPr id="48" name="Picture 47" descr="A black and white shoe print&#10;&#10;Description automatically generated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43" t="15713" r="49446" b="30348"/>
          <a:stretch>
            <a:fillRect/>
          </a:stretch>
        </p:blipFill>
        <p:spPr>
          <a:xfrm rot="5690470">
            <a:off x="981936" y="3800685"/>
            <a:ext cx="278570" cy="556271"/>
          </a:xfrm>
          <a:prstGeom prst="rect">
            <a:avLst/>
          </a:prstGeom>
        </p:spPr>
      </p:pic>
      <p:grpSp>
        <p:nvGrpSpPr>
          <p:cNvPr id="22" name="Group 21"/>
          <p:cNvGrpSpPr/>
          <p:nvPr/>
        </p:nvGrpSpPr>
        <p:grpSpPr>
          <a:xfrm>
            <a:off x="-1729" y="9513221"/>
            <a:ext cx="5042041" cy="926180"/>
            <a:chOff x="-1729" y="9746004"/>
            <a:chExt cx="5042041" cy="693395"/>
          </a:xfrm>
          <a:solidFill>
            <a:srgbClr val="0B509D"/>
          </a:solidFill>
        </p:grpSpPr>
        <p:sp>
          <p:nvSpPr>
            <p:cNvPr id="54" name="Rectangle 53"/>
            <p:cNvSpPr/>
            <p:nvPr/>
          </p:nvSpPr>
          <p:spPr>
            <a:xfrm>
              <a:off x="-1729" y="9746004"/>
              <a:ext cx="5042041" cy="693395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595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43280" y="9885401"/>
              <a:ext cx="4165815" cy="553998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solidFill>
                    <a:schemeClr val="bg1"/>
                  </a:solidFill>
                </a:rPr>
                <a:t>This graphical abstract represents the opinions of the authors. For a full list of declarations, including funding and author disclosure statements, and copyright information, please see the full text online. </a:t>
              </a:r>
              <a:endParaRPr lang="en-GB" sz="1000" dirty="0">
                <a:solidFill>
                  <a:schemeClr val="bg1"/>
                </a:solidFill>
              </a:endParaRPr>
            </a:p>
          </p:txBody>
        </p:sp>
      </p:grpSp>
      <p:sp>
        <p:nvSpPr>
          <p:cNvPr id="9" name="Rectangle 8"/>
          <p:cNvSpPr/>
          <p:nvPr/>
        </p:nvSpPr>
        <p:spPr>
          <a:xfrm>
            <a:off x="-1728" y="0"/>
            <a:ext cx="5042041" cy="1547291"/>
          </a:xfrm>
          <a:prstGeom prst="rect">
            <a:avLst/>
          </a:prstGeom>
          <a:solidFill>
            <a:srgbClr val="0B509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71884" y="540025"/>
            <a:ext cx="4894833" cy="968375"/>
          </a:xfrm>
          <a:prstGeom prst="rect">
            <a:avLst/>
          </a:prstGeom>
          <a:solidFill>
            <a:srgbClr val="0B509D"/>
          </a:solidFill>
          <a:ln>
            <a:noFill/>
          </a:ln>
          <a:effectLst>
            <a:softEdge rad="0"/>
          </a:effectLst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The Biomechanical Influence of Step Width on Typical Locomot</a:t>
            </a:r>
            <a:r>
              <a:rPr lang="en-US" altLang="en-GB" sz="1600" b="1" dirty="0">
                <a:solidFill>
                  <a:schemeClr val="bg1"/>
                </a:solidFill>
              </a:rPr>
              <a:t>or</a:t>
            </a:r>
            <a:r>
              <a:rPr lang="en-GB" sz="1600" b="1" dirty="0">
                <a:solidFill>
                  <a:schemeClr val="bg1"/>
                </a:solidFill>
              </a:rPr>
              <a:t> Activities</a:t>
            </a:r>
            <a:r>
              <a:rPr lang="en-US" altLang="en-GB" sz="1600" b="1" dirty="0">
                <a:solidFill>
                  <a:schemeClr val="bg1"/>
                </a:solidFill>
              </a:rPr>
              <a:t>: A Systematic Review</a:t>
            </a:r>
            <a:endParaRPr lang="en-GB" sz="1600" b="1" dirty="0">
              <a:solidFill>
                <a:schemeClr val="bg1"/>
              </a:solidFill>
            </a:endParaRPr>
          </a:p>
          <a:p>
            <a:endParaRPr lang="en-GB" sz="300" dirty="0">
              <a:solidFill>
                <a:schemeClr val="bg1"/>
              </a:solidFill>
            </a:endParaRPr>
          </a:p>
          <a:p>
            <a:r>
              <a:rPr lang="en-GB" sz="1100" dirty="0">
                <a:solidFill>
                  <a:schemeClr val="bg1"/>
                </a:solidFill>
              </a:rPr>
              <a:t>Yuan Wang, Qichang Mei, </a:t>
            </a:r>
            <a:r>
              <a:rPr lang="en-GB" sz="1100" dirty="0" err="1">
                <a:solidFill>
                  <a:schemeClr val="bg1"/>
                </a:solidFill>
              </a:rPr>
              <a:t>Hanhui</a:t>
            </a:r>
            <a:r>
              <a:rPr lang="en-GB" sz="1100" dirty="0">
                <a:solidFill>
                  <a:schemeClr val="bg1"/>
                </a:solidFill>
              </a:rPr>
              <a:t> Jiang, Karsten Hollander, Pieter Van den Berghe, Justin Fernandez, Yaodong Gu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250" y="1712791"/>
            <a:ext cx="4855845" cy="99562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algn="just">
              <a:buFont typeface="Arial" panose="020B0604020202020204" pitchFamily="34" charset="0"/>
              <a:buNone/>
            </a:pPr>
            <a:r>
              <a:rPr lang="en-US" sz="1830" b="1" dirty="0">
                <a:solidFill>
                  <a:schemeClr val="tx1"/>
                </a:solidFill>
              </a:rPr>
              <a:t>E</a:t>
            </a:r>
            <a:r>
              <a:rPr lang="en-US" altLang="en-GB" sz="1830" b="1" dirty="0">
                <a:solidFill>
                  <a:schemeClr val="tx1"/>
                </a:solidFill>
              </a:rPr>
              <a:t>ffect of </a:t>
            </a:r>
            <a:r>
              <a:rPr lang="en-GB" sz="1830" b="1" dirty="0">
                <a:solidFill>
                  <a:schemeClr val="tx1"/>
                </a:solidFill>
              </a:rPr>
              <a:t>acute changes in step width on the biomechanics of level walking, running and sprinting:</a:t>
            </a:r>
            <a:endParaRPr lang="en-GB" sz="1830" b="1" dirty="0">
              <a:solidFill>
                <a:schemeClr val="tx1"/>
              </a:solidFill>
            </a:endParaRPr>
          </a:p>
        </p:txBody>
      </p:sp>
      <p:pic>
        <p:nvPicPr>
          <p:cNvPr id="1026" name="Picture 2" descr="image00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34" y="9684196"/>
            <a:ext cx="504056" cy="6697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71884" y="8552"/>
            <a:ext cx="3499794" cy="461665"/>
          </a:xfrm>
          <a:prstGeom prst="rect">
            <a:avLst/>
          </a:prstGeom>
          <a:solidFill>
            <a:srgbClr val="0B509D"/>
          </a:solidFill>
          <a:ln>
            <a:noFill/>
          </a:ln>
          <a:effectLst>
            <a:softEdge rad="0"/>
          </a:effectLst>
        </p:spPr>
        <p:txBody>
          <a:bodyPr wrap="square" rtlCol="0">
            <a:spAutoFit/>
          </a:bodyPr>
          <a:lstStyle/>
          <a:p>
            <a:r>
              <a:rPr lang="en-GB" sz="2400" b="1" dirty="0">
                <a:solidFill>
                  <a:schemeClr val="bg1"/>
                </a:solidFill>
              </a:rPr>
              <a:t>SPORTS MEDICINE - OPEN</a:t>
            </a:r>
            <a:endParaRPr lang="en-GB" sz="2000" dirty="0">
              <a:solidFill>
                <a:schemeClr val="bg1"/>
              </a:solidFill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362" y="93664"/>
            <a:ext cx="804733" cy="32514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1884" y="8100020"/>
            <a:ext cx="4855845" cy="12160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/>
            <a:r>
              <a:rPr lang="en-US" sz="1600" b="1" dirty="0">
                <a:sym typeface="+mn-ea"/>
              </a:rPr>
              <a:t>CONCLUSION</a:t>
            </a:r>
            <a:r>
              <a:rPr lang="en-US" altLang="en-GB" sz="1600" b="1" dirty="0">
                <a:sym typeface="+mn-ea"/>
              </a:rPr>
              <a:t>: </a:t>
            </a:r>
            <a:r>
              <a:rPr lang="en-US" altLang="en-GB" sz="1600" dirty="0">
                <a:sym typeface="+mn-ea"/>
              </a:rPr>
              <a:t>Acute changes in step width affected walking, running, and sprinting biomechanics. In clinical practice, adjusting the width of one's steps may be a simple way to alter balance control and musculoskeletal loads associated with locomotor activities.</a:t>
            </a:r>
            <a:endParaRPr lang="en-US" altLang="en-GB" sz="1600" dirty="0">
              <a:sym typeface="+mn-ea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2449" y="2699092"/>
            <a:ext cx="498706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550" b="1" kern="100" dirty="0">
                <a:solidFill>
                  <a:schemeClr val="bg1">
                    <a:lumMod val="50000"/>
                  </a:schemeClr>
                </a:solidFill>
                <a:effectLst/>
                <a:latin typeface="Calibri (Body)"/>
                <a:ea typeface="仿宋" panose="02010609060101010101" pitchFamily="49" charset="-122"/>
                <a:cs typeface="Calibri Light" panose="020F0302020204030204" pitchFamily="34" charset="0"/>
              </a:rPr>
              <a:t>23 articles included, 399 participants</a:t>
            </a:r>
            <a:endParaRPr lang="en-US" sz="1550" b="1" kern="100" dirty="0">
              <a:solidFill>
                <a:schemeClr val="bg1">
                  <a:lumMod val="50000"/>
                </a:schemeClr>
              </a:solidFill>
              <a:effectLst/>
              <a:latin typeface="Calibri (Body)"/>
              <a:ea typeface="仿宋" panose="02010609060101010101" pitchFamily="49" charset="-122"/>
              <a:cs typeface="Calibri Light" panose="020F0302020204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550" b="1" kern="100" dirty="0">
                <a:solidFill>
                  <a:schemeClr val="bg1">
                    <a:lumMod val="50000"/>
                  </a:schemeClr>
                </a:solidFill>
                <a:effectLst/>
                <a:latin typeface="Calibri (Body)"/>
                <a:ea typeface="仿宋" panose="02010609060101010101" pitchFamily="49" charset="-122"/>
                <a:cs typeface="Calibri Light" panose="020F0302020204030204" pitchFamily="34" charset="0"/>
              </a:rPr>
              <a:t>The average quality score was 9 out of 14</a:t>
            </a:r>
            <a:endParaRPr lang="en-US" sz="1550" b="1" kern="100" dirty="0">
              <a:solidFill>
                <a:schemeClr val="bg1">
                  <a:lumMod val="50000"/>
                </a:schemeClr>
              </a:solidFill>
              <a:effectLst/>
              <a:latin typeface="Calibri (Body)"/>
              <a:ea typeface="仿宋" panose="02010609060101010101" pitchFamily="49" charset="-122"/>
              <a:cs typeface="Calibri Light" panose="020F0302020204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550" b="1" kern="100" dirty="0">
                <a:solidFill>
                  <a:schemeClr val="bg1">
                    <a:lumMod val="50000"/>
                  </a:schemeClr>
                </a:solidFill>
                <a:effectLst/>
                <a:latin typeface="Calibri (Body)"/>
                <a:ea typeface="仿宋" panose="02010609060101010101" pitchFamily="49" charset="-122"/>
                <a:cs typeface="Calibri Light" panose="020F0302020204030204" pitchFamily="34" charset="0"/>
              </a:rPr>
              <a:t>Evaluation of muscle activity, kinematics and</a:t>
            </a:r>
            <a:r>
              <a:rPr lang="en-US" sz="1550" b="1" kern="100" dirty="0">
                <a:solidFill>
                  <a:schemeClr val="bg1">
                    <a:lumMod val="50000"/>
                  </a:schemeClr>
                </a:solidFill>
                <a:latin typeface="Calibri (Body)"/>
                <a:ea typeface="仿宋" panose="02010609060101010101" pitchFamily="49" charset="-122"/>
                <a:cs typeface="Calibri Light" panose="020F0302020204030204" pitchFamily="34" charset="0"/>
              </a:rPr>
              <a:t> kinetics</a:t>
            </a:r>
            <a:endParaRPr lang="en-US" sz="1550" b="1" kern="100" dirty="0">
              <a:solidFill>
                <a:schemeClr val="bg1">
                  <a:lumMod val="50000"/>
                </a:schemeClr>
              </a:solidFill>
              <a:latin typeface="Calibri (Body)"/>
              <a:ea typeface="仿宋" panose="02010609060101010101" pitchFamily="49" charset="-122"/>
              <a:cs typeface="Calibri Light" panose="020F0302020204030204" pitchFamily="34" charset="0"/>
            </a:endParaRPr>
          </a:p>
        </p:txBody>
      </p:sp>
      <p:pic>
        <p:nvPicPr>
          <p:cNvPr id="20" name="图片 1" descr="步宽V3 (1)_结果"/>
          <p:cNvPicPr>
            <a:picLocks noChangeAspect="1"/>
          </p:cNvPicPr>
          <p:nvPr/>
        </p:nvPicPr>
        <p:blipFill rotWithShape="1">
          <a:blip r:embed="rId4"/>
          <a:srcRect l="33678" t="9694" r="46729" b="53236"/>
          <a:stretch>
            <a:fillRect/>
          </a:stretch>
        </p:blipFill>
        <p:spPr>
          <a:xfrm flipH="1">
            <a:off x="4062615" y="6093330"/>
            <a:ext cx="754077" cy="1530148"/>
          </a:xfrm>
          <a:prstGeom prst="rect">
            <a:avLst/>
          </a:prstGeom>
        </p:spPr>
      </p:pic>
      <p:cxnSp>
        <p:nvCxnSpPr>
          <p:cNvPr id="31" name="Straight Arrow Connector 30"/>
          <p:cNvCxnSpPr/>
          <p:nvPr/>
        </p:nvCxnSpPr>
        <p:spPr>
          <a:xfrm flipV="1">
            <a:off x="876520" y="4117634"/>
            <a:ext cx="1" cy="457200"/>
          </a:xfrm>
          <a:prstGeom prst="straightConnector1">
            <a:avLst/>
          </a:prstGeom>
          <a:ln w="28575"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2115426" y="3797594"/>
            <a:ext cx="0" cy="777240"/>
          </a:xfrm>
          <a:prstGeom prst="straightConnector1">
            <a:avLst/>
          </a:prstGeom>
          <a:ln w="28575">
            <a:solidFill>
              <a:srgbClr val="9A2B20"/>
            </a:solidFill>
            <a:headEnd type="triangle"/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 flipV="1">
            <a:off x="3556988" y="4163354"/>
            <a:ext cx="0" cy="411480"/>
          </a:xfrm>
          <a:prstGeom prst="straightConnector1">
            <a:avLst/>
          </a:prstGeom>
          <a:ln w="28575">
            <a:solidFill>
              <a:srgbClr val="3C8B37"/>
            </a:solidFill>
            <a:headEnd type="triangle"/>
            <a:tailEnd type="triangle"/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2096818" y="4273909"/>
            <a:ext cx="649542" cy="31685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algn="just">
              <a:buFont typeface="Arial" panose="020B0604020202020204" pitchFamily="34" charset="0"/>
              <a:buNone/>
            </a:pPr>
            <a:r>
              <a:rPr lang="en-GB" sz="1400" b="1" dirty="0">
                <a:solidFill>
                  <a:srgbClr val="9A2B20"/>
                </a:solidFill>
              </a:rPr>
              <a:t>Wider</a:t>
            </a:r>
            <a:endParaRPr lang="en-GB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859575" y="4282988"/>
            <a:ext cx="116092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elf-selected</a:t>
            </a:r>
            <a:endParaRPr lang="en-GB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524744" y="4264405"/>
            <a:ext cx="1343922" cy="36359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indent="0" algn="just">
              <a:buFont typeface="Arial" panose="020B0604020202020204" pitchFamily="34" charset="0"/>
              <a:buNone/>
            </a:pPr>
            <a:r>
              <a:rPr lang="en-US" altLang="en-GB" sz="1400" b="1" dirty="0">
                <a:solidFill>
                  <a:srgbClr val="3C8B37"/>
                </a:solidFill>
              </a:rPr>
              <a:t>N</a:t>
            </a:r>
            <a:r>
              <a:rPr lang="en-GB" sz="1400" b="1" dirty="0">
                <a:solidFill>
                  <a:srgbClr val="3C8B37"/>
                </a:solidFill>
              </a:rPr>
              <a:t>arrow</a:t>
            </a:r>
            <a:r>
              <a:rPr lang="en-US" altLang="en-GB" sz="1400" b="1" dirty="0">
                <a:solidFill>
                  <a:srgbClr val="3C8B37"/>
                </a:solidFill>
              </a:rPr>
              <a:t>er</a:t>
            </a:r>
            <a:endParaRPr lang="en-US" altLang="en-GB" sz="1400" b="1" dirty="0">
              <a:solidFill>
                <a:srgbClr val="3C8B37"/>
              </a:solidFill>
            </a:endParaRPr>
          </a:p>
        </p:txBody>
      </p:sp>
      <p:sp>
        <p:nvSpPr>
          <p:cNvPr id="24" name="文本框 2"/>
          <p:cNvSpPr txBox="1"/>
          <p:nvPr/>
        </p:nvSpPr>
        <p:spPr>
          <a:xfrm>
            <a:off x="215265" y="7451725"/>
            <a:ext cx="3774440" cy="30797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/>
            <a:r>
              <a:rPr lang="en-US" sz="1100" dirty="0">
                <a:sym typeface="+mn-ea"/>
              </a:rPr>
              <a:t>Narrower step width may result in poor balance, higher impact loading and reduced running performance (see full article).  </a:t>
            </a:r>
            <a:endParaRPr lang="en-US" altLang="en-GB" sz="1100" dirty="0">
              <a:sym typeface="+mn-ea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367780" y="4912565"/>
            <a:ext cx="3604652" cy="26225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/>
            <a:r>
              <a:rPr lang="en-GB" sz="1600" b="1" dirty="0">
                <a:solidFill>
                  <a:srgbClr val="9A2B20"/>
                </a:solidFill>
              </a:rPr>
              <a:t>WALKING:</a:t>
            </a:r>
            <a:endParaRPr lang="en-GB" sz="1600" b="1" dirty="0">
              <a:solidFill>
                <a:srgbClr val="9A2B20"/>
              </a:solidFill>
            </a:endParaRPr>
          </a:p>
          <a:p>
            <a:pPr algn="just"/>
            <a:r>
              <a:rPr lang="en-GB" sz="1400" dirty="0"/>
              <a:t>↑ support base</a:t>
            </a:r>
            <a:endParaRPr lang="en-GB" sz="1400" dirty="0"/>
          </a:p>
          <a:p>
            <a:pPr algn="just"/>
            <a:r>
              <a:rPr lang="en-GB" sz="1400" dirty="0"/>
              <a:t>↑ gluteus </a:t>
            </a:r>
            <a:r>
              <a:rPr lang="en-GB" sz="1400" dirty="0" err="1"/>
              <a:t>medius</a:t>
            </a:r>
            <a:r>
              <a:rPr lang="en-GB" sz="1400" dirty="0"/>
              <a:t> and </a:t>
            </a:r>
            <a:r>
              <a:rPr lang="en-GB" sz="1400" dirty="0" err="1"/>
              <a:t>minimus</a:t>
            </a:r>
            <a:r>
              <a:rPr lang="en-GB" sz="1400" dirty="0"/>
              <a:t> activation</a:t>
            </a:r>
            <a:endParaRPr lang="en-GB" sz="1400" dirty="0"/>
          </a:p>
          <a:p>
            <a:pPr algn="just"/>
            <a:r>
              <a:rPr lang="en-GB" sz="1400" dirty="0"/>
              <a:t>∆ in 3D knee kinetics </a:t>
            </a:r>
            <a:r>
              <a:rPr lang="en-GB" sz="1300" dirty="0"/>
              <a:t>(e.g., ↑ extension moment, ↓</a:t>
            </a:r>
            <a:r>
              <a:rPr lang="en-US" sz="1300" dirty="0"/>
              <a:t> peak knee adduction moment and knee adduction moment angular impulse</a:t>
            </a:r>
            <a:r>
              <a:rPr lang="en-GB" sz="1300" dirty="0"/>
              <a:t>)</a:t>
            </a:r>
            <a:endParaRPr lang="en-GB" sz="1300" dirty="0">
              <a:highlight>
                <a:srgbClr val="FFFF00"/>
              </a:highlight>
            </a:endParaRPr>
          </a:p>
          <a:p>
            <a:pPr algn="just"/>
            <a:endParaRPr lang="en-GB" sz="1600" dirty="0"/>
          </a:p>
          <a:p>
            <a:pPr algn="just"/>
            <a:r>
              <a:rPr lang="en-GB" sz="1600" b="1" dirty="0">
                <a:solidFill>
                  <a:srgbClr val="9A2B20"/>
                </a:solidFill>
              </a:rPr>
              <a:t>RUNNING</a:t>
            </a:r>
            <a:r>
              <a:rPr lang="en-US" altLang="en-GB" sz="1600" b="1" dirty="0">
                <a:solidFill>
                  <a:srgbClr val="9A2B20"/>
                </a:solidFill>
              </a:rPr>
              <a:t>:</a:t>
            </a:r>
            <a:endParaRPr lang="en-GB" sz="1600" b="1" dirty="0">
              <a:solidFill>
                <a:srgbClr val="9A2B20"/>
              </a:solidFill>
            </a:endParaRPr>
          </a:p>
          <a:p>
            <a:pPr algn="just"/>
            <a:r>
              <a:rPr lang="en-GB" sz="1400" dirty="0"/>
              <a:t>↓ Peak knee abduction moment</a:t>
            </a:r>
            <a:endParaRPr lang="en-GB" sz="1400" dirty="0"/>
          </a:p>
          <a:p>
            <a:pPr algn="just"/>
            <a:r>
              <a:rPr lang="en-GB" sz="1400" dirty="0"/>
              <a:t>↓ Peak rearfoot eversion angle</a:t>
            </a:r>
            <a:endParaRPr lang="en-GB" sz="1400" dirty="0"/>
          </a:p>
          <a:p>
            <a:pPr algn="just"/>
            <a:r>
              <a:rPr lang="en-GB" sz="1400" dirty="0"/>
              <a:t>↓ Tibial shear stress</a:t>
            </a:r>
            <a:endParaRPr lang="en-GB" sz="1400" dirty="0"/>
          </a:p>
        </p:txBody>
      </p:sp>
      <p:cxnSp>
        <p:nvCxnSpPr>
          <p:cNvPr id="60" name="Straight Connector 59"/>
          <p:cNvCxnSpPr/>
          <p:nvPr/>
        </p:nvCxnSpPr>
        <p:spPr>
          <a:xfrm>
            <a:off x="323380" y="4582876"/>
            <a:ext cx="429768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8" name="Arrow: Down 1027"/>
          <p:cNvSpPr/>
          <p:nvPr/>
        </p:nvSpPr>
        <p:spPr>
          <a:xfrm>
            <a:off x="2252514" y="4684717"/>
            <a:ext cx="147725" cy="175196"/>
          </a:xfrm>
          <a:prstGeom prst="down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9" name="图片 1" descr="步宽V3 (1)_结果"/>
          <p:cNvPicPr>
            <a:picLocks noChangeAspect="1"/>
          </p:cNvPicPr>
          <p:nvPr/>
        </p:nvPicPr>
        <p:blipFill rotWithShape="1">
          <a:blip r:embed="rId4"/>
          <a:srcRect l="34671" t="57541" r="47662" b="5651"/>
          <a:stretch>
            <a:fillRect/>
          </a:stretch>
        </p:blipFill>
        <p:spPr>
          <a:xfrm>
            <a:off x="506678" y="4987809"/>
            <a:ext cx="651585" cy="1456027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15265" y="7901940"/>
            <a:ext cx="4020820" cy="24066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100" dirty="0">
                <a:sym typeface="+mn-ea"/>
              </a:rPr>
              <a:t>Results of the narrow condition can be found in the article.</a:t>
            </a:r>
            <a:endParaRPr lang="en-US" sz="1100" dirty="0"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TVjMmM4YjVlZDVlZjQ0Y2UzMzJmYTRhMjcyZTQzY2MifQ==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01</Words>
  <Application>WPS 演示</Application>
  <PresentationFormat>Custom</PresentationFormat>
  <Paragraphs>3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Calibri (Body)</vt:lpstr>
      <vt:lpstr>Calibri</vt:lpstr>
      <vt:lpstr>仿宋</vt:lpstr>
      <vt:lpstr>Calibri Light</vt:lpstr>
      <vt:lpstr>微软雅黑</vt:lpstr>
      <vt:lpstr>Arial Unicode MS</vt:lpstr>
      <vt:lpstr>等线</vt:lpstr>
      <vt:lpstr>Office Theme</vt:lpstr>
      <vt:lpstr>PowerPoint 演示文稿</vt:lpstr>
    </vt:vector>
  </TitlesOfParts>
  <Company>Macmillan Publishing Lt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Vautrinot - Springer Healthcare UK</dc:creator>
  <cp:lastModifiedBy>Y Wang</cp:lastModifiedBy>
  <cp:revision>115</cp:revision>
  <dcterms:created xsi:type="dcterms:W3CDTF">2019-04-17T15:10:00Z</dcterms:created>
  <dcterms:modified xsi:type="dcterms:W3CDTF">2024-06-28T09:53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EFF2C346A1944BBAF14348ABDC77340_12</vt:lpwstr>
  </property>
  <property fmtid="{D5CDD505-2E9C-101B-9397-08002B2CF9AE}" pid="3" name="KSOProductBuildVer">
    <vt:lpwstr>2052-12.1.0.16417</vt:lpwstr>
  </property>
</Properties>
</file>